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49" r:id="rId2"/>
  </p:sldIdLst>
  <p:sldSz cx="6858000" cy="9144000" type="screen4x3"/>
  <p:notesSz cx="9939338" cy="68072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2ED522B7-1C83-8829-CACA-9FB753ED7AE0}" name="崇史 黒江" initials="崇史" userId="a22cf01eb3c45466" providerId="Windows Liv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石井源一郎" initials="石井" lastIdx="22" clrIdx="0"/>
  <p:cmAuthor id="7" name="石井 源一郎" initials="石井" lastIdx="43" clrIdx="7"/>
  <p:cmAuthor id="1" name="tomo" initials="t" lastIdx="7" clrIdx="1"/>
  <p:cmAuthor id="8" name="ISHII" initials="I" lastIdx="38" clrIdx="8">
    <p:extLst>
      <p:ext uri="{19B8F6BF-5375-455C-9EA6-DF929625EA0E}">
        <p15:presenceInfo xmlns:p15="http://schemas.microsoft.com/office/powerpoint/2012/main" userId="ISHII" providerId="None"/>
      </p:ext>
    </p:extLst>
  </p:cmAuthor>
  <p:cmAuthor id="2" name="石井源一郎" initials="石井源一郎" lastIdx="5" clrIdx="2"/>
  <p:cmAuthor id="3" name="ishiiP2292" initials="i" lastIdx="10" clrIdx="3"/>
  <p:cmAuthor id="4" name="TI" initials="T" lastIdx="1" clrIdx="4"/>
  <p:cmAuthor id="5" name="石井　源一郎" initials="石井　源一郎" lastIdx="63" clrIdx="5"/>
  <p:cmAuthor id="6" name="崇史 黒江" initials="崇史" lastIdx="155" clrIdx="6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217" autoAdjust="0"/>
    <p:restoredTop sz="96242" autoAdjust="0"/>
  </p:normalViewPr>
  <p:slideViewPr>
    <p:cSldViewPr>
      <p:cViewPr varScale="1">
        <p:scale>
          <a:sx n="42" d="100"/>
          <a:sy n="42" d="100"/>
        </p:scale>
        <p:origin x="2456" y="44"/>
      </p:cViewPr>
      <p:guideLst>
        <p:guide orient="horz" pos="2880"/>
        <p:guide pos="216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Relationship Id="rId9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3" y="0"/>
            <a:ext cx="4307047" cy="340360"/>
          </a:xfrm>
          <a:prstGeom prst="rect">
            <a:avLst/>
          </a:prstGeom>
        </p:spPr>
        <p:txBody>
          <a:bodyPr vert="horz" lIns="92229" tIns="46115" rIns="92229" bIns="46115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629994" y="0"/>
            <a:ext cx="4307047" cy="340360"/>
          </a:xfrm>
          <a:prstGeom prst="rect">
            <a:avLst/>
          </a:prstGeom>
        </p:spPr>
        <p:txBody>
          <a:bodyPr vert="horz" lIns="92229" tIns="46115" rIns="92229" bIns="46115" rtlCol="0"/>
          <a:lstStyle>
            <a:lvl1pPr algn="r">
              <a:defRPr sz="1200"/>
            </a:lvl1pPr>
          </a:lstStyle>
          <a:p>
            <a:fld id="{18D96FBF-3B6B-4E7C-B033-A5D0AF30607C}" type="datetimeFigureOut">
              <a:rPr kumimoji="1" lang="ja-JP" altLang="en-US" smtClean="0"/>
              <a:t>2022/3/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013200" y="509588"/>
            <a:ext cx="1912938" cy="25542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229" tIns="46115" rIns="92229" bIns="46115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93935" y="3233422"/>
            <a:ext cx="7951470" cy="3063240"/>
          </a:xfrm>
          <a:prstGeom prst="rect">
            <a:avLst/>
          </a:prstGeom>
        </p:spPr>
        <p:txBody>
          <a:bodyPr vert="horz" lIns="92229" tIns="46115" rIns="92229" bIns="46115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3" y="6465659"/>
            <a:ext cx="4307047" cy="340360"/>
          </a:xfrm>
          <a:prstGeom prst="rect">
            <a:avLst/>
          </a:prstGeom>
        </p:spPr>
        <p:txBody>
          <a:bodyPr vert="horz" lIns="92229" tIns="46115" rIns="92229" bIns="46115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629994" y="6465659"/>
            <a:ext cx="4307047" cy="340360"/>
          </a:xfrm>
          <a:prstGeom prst="rect">
            <a:avLst/>
          </a:prstGeom>
        </p:spPr>
        <p:txBody>
          <a:bodyPr vert="horz" lIns="92229" tIns="46115" rIns="92229" bIns="46115" rtlCol="0" anchor="b"/>
          <a:lstStyle>
            <a:lvl1pPr algn="r">
              <a:defRPr sz="1200"/>
            </a:lvl1pPr>
          </a:lstStyle>
          <a:p>
            <a:fld id="{FC1018B4-28F9-43F3-8ACE-503A9AFA73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04094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3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18183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3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28036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3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85332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3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37961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3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4520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3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37685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3/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48135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3/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58378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3/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56925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3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92624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3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30677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53CC40-0A3F-488B-8C7F-CE66E8AB49E0}" type="datetimeFigureOut">
              <a:rPr kumimoji="1" lang="ja-JP" altLang="en-US" smtClean="0"/>
              <a:t>2022/3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28110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AD721C7-F29A-4567-8C8A-EC044C518BC1}"/>
              </a:ext>
            </a:extLst>
          </p:cNvPr>
          <p:cNvSpPr txBox="1"/>
          <p:nvPr/>
        </p:nvSpPr>
        <p:spPr>
          <a:xfrm>
            <a:off x="0" y="179512"/>
            <a:ext cx="6858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メイリオ" panose="020B0604030504040204" pitchFamily="50" charset="-128"/>
                <a:cs typeface="Helvetica" panose="020B0604020202020204" pitchFamily="34" charset="0"/>
              </a:rPr>
              <a:t>Table S1.</a:t>
            </a:r>
            <a:r>
              <a:rPr kumimoji="1" lang="ja-JP" altLang="en-US" sz="1400" b="1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メイリオ" panose="020B0604030504040204" pitchFamily="50" charset="-128"/>
                <a:cs typeface="Helvetica" panose="020B0604020202020204" pitchFamily="34" charset="0"/>
              </a:rPr>
              <a:t> </a:t>
            </a: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游明朝" panose="02020400000000000000" pitchFamily="18" charset="-128"/>
                <a:cs typeface="Helvetica" panose="020B0604020202020204" pitchFamily="34" charset="0"/>
              </a:rPr>
              <a:t>Patient characteristics in current study</a:t>
            </a:r>
            <a:endParaRPr kumimoji="1" lang="en-US" altLang="ja-JP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HG明朝E"/>
              <a:cs typeface="Helvetica" panose="020B0604020202020204" pitchFamily="34" charset="0"/>
            </a:endParaRPr>
          </a:p>
        </p:txBody>
      </p:sp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B54FE7F3-6AB0-4DE9-A75C-D8E82DBBD91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002977"/>
              </p:ext>
            </p:extLst>
          </p:nvPr>
        </p:nvGraphicFramePr>
        <p:xfrm>
          <a:off x="188639" y="653573"/>
          <a:ext cx="6480721" cy="7590835"/>
        </p:xfrm>
        <a:graphic>
          <a:graphicData uri="http://schemas.openxmlformats.org/drawingml/2006/table">
            <a:tbl>
              <a:tblPr/>
              <a:tblGrid>
                <a:gridCol w="298061">
                  <a:extLst>
                    <a:ext uri="{9D8B030D-6E8A-4147-A177-3AD203B41FA5}">
                      <a16:colId xmlns:a16="http://schemas.microsoft.com/office/drawing/2014/main" val="3963233110"/>
                    </a:ext>
                  </a:extLst>
                </a:gridCol>
                <a:gridCol w="687034">
                  <a:extLst>
                    <a:ext uri="{9D8B030D-6E8A-4147-A177-3AD203B41FA5}">
                      <a16:colId xmlns:a16="http://schemas.microsoft.com/office/drawing/2014/main" val="172486512"/>
                    </a:ext>
                  </a:extLst>
                </a:gridCol>
                <a:gridCol w="2008504">
                  <a:extLst>
                    <a:ext uri="{9D8B030D-6E8A-4147-A177-3AD203B41FA5}">
                      <a16:colId xmlns:a16="http://schemas.microsoft.com/office/drawing/2014/main" val="3140707734"/>
                    </a:ext>
                  </a:extLst>
                </a:gridCol>
                <a:gridCol w="1063020">
                  <a:extLst>
                    <a:ext uri="{9D8B030D-6E8A-4147-A177-3AD203B41FA5}">
                      <a16:colId xmlns:a16="http://schemas.microsoft.com/office/drawing/2014/main" val="971991028"/>
                    </a:ext>
                  </a:extLst>
                </a:gridCol>
                <a:gridCol w="298061">
                  <a:extLst>
                    <a:ext uri="{9D8B030D-6E8A-4147-A177-3AD203B41FA5}">
                      <a16:colId xmlns:a16="http://schemas.microsoft.com/office/drawing/2014/main" val="1643212998"/>
                    </a:ext>
                  </a:extLst>
                </a:gridCol>
                <a:gridCol w="1076008">
                  <a:extLst>
                    <a:ext uri="{9D8B030D-6E8A-4147-A177-3AD203B41FA5}">
                      <a16:colId xmlns:a16="http://schemas.microsoft.com/office/drawing/2014/main" val="1639128660"/>
                    </a:ext>
                  </a:extLst>
                </a:gridCol>
                <a:gridCol w="90912">
                  <a:extLst>
                    <a:ext uri="{9D8B030D-6E8A-4147-A177-3AD203B41FA5}">
                      <a16:colId xmlns:a16="http://schemas.microsoft.com/office/drawing/2014/main" val="1581806632"/>
                    </a:ext>
                  </a:extLst>
                </a:gridCol>
                <a:gridCol w="959121">
                  <a:extLst>
                    <a:ext uri="{9D8B030D-6E8A-4147-A177-3AD203B41FA5}">
                      <a16:colId xmlns:a16="http://schemas.microsoft.com/office/drawing/2014/main" val="2200101232"/>
                    </a:ext>
                  </a:extLst>
                </a:gridCol>
              </a:tblGrid>
              <a:tr h="191484">
                <a:tc>
                  <a:txBody>
                    <a:bodyPr/>
                    <a:lstStyle/>
                    <a:p>
                      <a:pPr algn="l" fontAlgn="ctr"/>
                      <a:r>
                        <a:rPr kumimoji="1" lang="ja-JP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1" lang="ja-JP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1" lang="ja-JP" sz="1400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  <a:endParaRPr lang="ja-JP" sz="14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ja-JP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1" lang="ja-JP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ja-JP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1" lang="ja-JP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1" lang="ja-JP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70061088"/>
                  </a:ext>
                </a:extLst>
              </a:tr>
              <a:tr h="191484">
                <a:tc>
                  <a:txBody>
                    <a:bodyPr/>
                    <a:lstStyle/>
                    <a:p>
                      <a:pPr algn="l" fontAlgn="ctr"/>
                      <a:r>
                        <a:rPr kumimoji="1" lang="ja-JP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1" lang="ja-JP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1" lang="ja-JP" sz="1400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  <a:endParaRPr lang="ja-JP" sz="14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Tumor necrosis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1" lang="ja-JP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1" lang="ja-JP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6888843"/>
                  </a:ext>
                </a:extLst>
              </a:tr>
              <a:tr h="191484"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N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1" lang="ja-JP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GN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64030003"/>
                  </a:ext>
                </a:extLst>
              </a:tr>
              <a:tr h="191484"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n = 33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n = 48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6308152"/>
                  </a:ext>
                </a:extLst>
              </a:tr>
              <a:tr h="191484">
                <a:tc gridSpan="3">
                  <a:txBody>
                    <a:bodyPr/>
                    <a:lstStyle/>
                    <a:p>
                      <a:pPr algn="l" fontAlgn="ctr"/>
                      <a:r>
                        <a:rPr kumimoji="1" lang="en-US" sz="1400" b="1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Features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kumimoji="1" lang="en-US" sz="1400" b="1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n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1" lang="ja-JP" sz="1400" b="1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1" lang="en-US" sz="1400" b="1" i="1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23641264"/>
                  </a:ext>
                </a:extLst>
              </a:tr>
              <a:tr h="191484">
                <a:tc gridSpan="3">
                  <a:txBody>
                    <a:bodyPr/>
                    <a:lstStyle/>
                    <a:p>
                      <a:pPr algn="l" fontAlgn="ctr"/>
                      <a:r>
                        <a:rPr kumimoji="1" lang="en-US" sz="1400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ge</a:t>
                      </a:r>
                      <a:endParaRPr lang="ja-JP" sz="14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942</a:t>
                      </a:r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50232122"/>
                  </a:ext>
                </a:extLst>
              </a:tr>
              <a:tr h="191484"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400" kern="0">
                          <a:effectLst/>
                          <a:latin typeface="+mn-lt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Median (25%-75%)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kern="0">
                          <a:effectLst/>
                          <a:latin typeface="+mn-lt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7 (58-75)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kern="0">
                          <a:effectLst/>
                          <a:latin typeface="+mn-lt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5 (60-73.25)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58610253"/>
                  </a:ext>
                </a:extLst>
              </a:tr>
              <a:tr h="191484">
                <a:tc gridSpan="3">
                  <a:txBody>
                    <a:bodyPr/>
                    <a:lstStyle/>
                    <a:p>
                      <a:pPr algn="l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ex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421 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34290154"/>
                  </a:ext>
                </a:extLst>
              </a:tr>
              <a:tr h="191484"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ale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4 (73%)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9 (81%)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1177947"/>
                  </a:ext>
                </a:extLst>
              </a:tr>
              <a:tr h="191484"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Female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 (27%)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 (19%)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67587620"/>
                  </a:ext>
                </a:extLst>
              </a:tr>
              <a:tr h="191484">
                <a:tc gridSpan="3">
                  <a:txBody>
                    <a:bodyPr/>
                    <a:lstStyle/>
                    <a:p>
                      <a:pPr algn="l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eft or Right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373 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47932230"/>
                  </a:ext>
                </a:extLst>
              </a:tr>
              <a:tr h="191484"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eft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5 (45%)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7 (56%)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97886492"/>
                  </a:ext>
                </a:extLst>
              </a:tr>
              <a:tr h="191484"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ight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8 (55%)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1 (44%)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46228131"/>
                  </a:ext>
                </a:extLst>
              </a:tr>
              <a:tr h="191484">
                <a:tc gridSpan="3">
                  <a:txBody>
                    <a:bodyPr/>
                    <a:lstStyle/>
                    <a:p>
                      <a:pPr algn="l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Tumor size (cm)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263 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9080513"/>
                  </a:ext>
                </a:extLst>
              </a:tr>
              <a:tr h="191484"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400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edian (25%-75%)</a:t>
                      </a:r>
                      <a:endParaRPr lang="ja-JP" sz="14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kern="0">
                          <a:effectLst/>
                          <a:latin typeface="+mn-lt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7.0 (4.2-8.6)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kern="0">
                          <a:effectLst/>
                          <a:latin typeface="+mn-lt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.2 (3.9-7.5)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39946888"/>
                  </a:ext>
                </a:extLst>
              </a:tr>
              <a:tr h="191484">
                <a:tc gridSpan="3">
                  <a:txBody>
                    <a:bodyPr/>
                    <a:lstStyle/>
                    <a:p>
                      <a:pPr algn="l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Histology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164 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69635764"/>
                  </a:ext>
                </a:extLst>
              </a:tr>
              <a:tr h="191484"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lear cell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6 (79%)</a:t>
                      </a:r>
                      <a:endParaRPr lang="ja-JP" sz="14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2 (67%)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40903284"/>
                  </a:ext>
                </a:extLst>
              </a:tr>
              <a:tr h="191484"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apillary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 (21%)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1 (23%)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69026955"/>
                  </a:ext>
                </a:extLst>
              </a:tr>
              <a:tr h="191484"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hromophobe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 (0%)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 (10%)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9923423"/>
                  </a:ext>
                </a:extLst>
              </a:tr>
              <a:tr h="191484">
                <a:tc gridSpan="3">
                  <a:txBody>
                    <a:bodyPr/>
                    <a:lstStyle/>
                    <a:p>
                      <a:pPr algn="l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T staging category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105 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39395194"/>
                  </a:ext>
                </a:extLst>
              </a:tr>
              <a:tr h="191484"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T 1 - 2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6 (48%)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3 (69%)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97808808"/>
                  </a:ext>
                </a:extLst>
              </a:tr>
              <a:tr h="191484"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T 3 - 4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7 (52%)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5 (31%)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20081403"/>
                  </a:ext>
                </a:extLst>
              </a:tr>
              <a:tr h="191484">
                <a:tc gridSpan="3">
                  <a:txBody>
                    <a:bodyPr/>
                    <a:lstStyle/>
                    <a:p>
                      <a:pPr algn="l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WHO / ISUP grade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006 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68155339"/>
                  </a:ext>
                </a:extLst>
              </a:tr>
              <a:tr h="191484"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400" kern="0">
                          <a:effectLst/>
                          <a:latin typeface="+mn-lt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kern="0">
                          <a:effectLst/>
                          <a:latin typeface="+mn-lt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 (0%)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kern="0">
                          <a:effectLst/>
                          <a:latin typeface="+mn-lt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 (2%)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15442861"/>
                  </a:ext>
                </a:extLst>
              </a:tr>
              <a:tr h="191484"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400" kern="0">
                          <a:effectLst/>
                          <a:latin typeface="+mn-lt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kern="0">
                          <a:effectLst/>
                          <a:latin typeface="+mn-lt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4 (12%)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kern="0">
                          <a:effectLst/>
                          <a:latin typeface="+mn-lt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6 (37%)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90105095"/>
                  </a:ext>
                </a:extLst>
              </a:tr>
              <a:tr h="191484">
                <a:tc>
                  <a:txBody>
                    <a:bodyPr/>
                    <a:lstStyle/>
                    <a:p>
                      <a:pPr algn="l"/>
                      <a:r>
                        <a:rPr lang="en-US" sz="1400" ker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9 (58%)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400" kern="0">
                          <a:effectLst/>
                          <a:latin typeface="+mn-lt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3 (53%)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400" kern="0">
                          <a:effectLst/>
                          <a:latin typeface="+mn-lt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400" ker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19956360"/>
                  </a:ext>
                </a:extLst>
              </a:tr>
              <a:tr h="191484">
                <a:tc>
                  <a:txBody>
                    <a:bodyPr/>
                    <a:lstStyle/>
                    <a:p>
                      <a:pPr algn="l"/>
                      <a:r>
                        <a:rPr lang="en-US" sz="1400" ker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0 (30%)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400" kern="0">
                          <a:effectLst/>
                          <a:latin typeface="+mn-lt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 (7%)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400" kern="0">
                          <a:effectLst/>
                          <a:latin typeface="+mn-lt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400" kern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302041"/>
                  </a:ext>
                </a:extLst>
              </a:tr>
              <a:tr h="191484">
                <a:tc gridSpan="3">
                  <a:txBody>
                    <a:bodyPr/>
                    <a:lstStyle/>
                    <a:p>
                      <a:pPr algn="l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arcomatoid differentiation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039 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93059567"/>
                  </a:ext>
                </a:extLst>
              </a:tr>
              <a:tr h="191484"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bsent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8 (85%)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7 (98%)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81827723"/>
                  </a:ext>
                </a:extLst>
              </a:tr>
              <a:tr h="191484"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resent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 (15%)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 (2%)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24140164"/>
                  </a:ext>
                </a:extLst>
              </a:tr>
              <a:tr h="191484">
                <a:tc gridSpan="3">
                  <a:txBody>
                    <a:bodyPr/>
                    <a:lstStyle/>
                    <a:p>
                      <a:pPr algn="l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istant metastasis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015 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11177302"/>
                  </a:ext>
                </a:extLst>
              </a:tr>
              <a:tr h="191484"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bsent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1 (64%)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2 (88%)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12039526"/>
                  </a:ext>
                </a:extLst>
              </a:tr>
              <a:tr h="191484"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resent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2 (36%)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 (12%)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33957173"/>
                  </a:ext>
                </a:extLst>
              </a:tr>
              <a:tr h="191484">
                <a:tc>
                  <a:txBody>
                    <a:bodyPr/>
                    <a:lstStyle/>
                    <a:p>
                      <a:pPr algn="l" fontAlgn="ctr"/>
                      <a:r>
                        <a:rPr kumimoji="1" lang="ja-JP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l" fontAlgn="ctr"/>
                      <a:r>
                        <a:rPr kumimoji="1" lang="en-US" sz="1400" i="1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 values &lt;0.05 were considered significant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1" lang="ja-JP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ja-JP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1" lang="ja-JP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1" lang="ja-JP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50268502"/>
                  </a:ext>
                </a:extLst>
              </a:tr>
              <a:tr h="186274"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 dirty="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 dirty="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70706772"/>
                  </a:ext>
                </a:extLst>
              </a:tr>
            </a:tbl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E2C244D-CA1C-45CB-B37D-3C6A2DE08184}"/>
              </a:ext>
            </a:extLst>
          </p:cNvPr>
          <p:cNvSpPr txBox="1"/>
          <p:nvPr/>
        </p:nvSpPr>
        <p:spPr>
          <a:xfrm>
            <a:off x="0" y="8244408"/>
            <a:ext cx="6858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/>
              <a:t>Abbreviations: DN, dirty necrosis; GN, ghost necrosis; </a:t>
            </a:r>
            <a:r>
              <a:rPr kumimoji="1" lang="en-US" altLang="ja-JP" sz="1400" dirty="0" err="1"/>
              <a:t>pT</a:t>
            </a:r>
            <a:r>
              <a:rPr kumimoji="1" lang="en-US" altLang="ja-JP" sz="1400" dirty="0"/>
              <a:t>, pathological T; WHO/ISUP, World Health Organization / International Society of Urological Pathology.</a:t>
            </a:r>
            <a:endParaRPr kumimoji="1"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38311630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ユーザー定義 4">
      <a:majorFont>
        <a:latin typeface="Times New Roman"/>
        <a:ea typeface="HGｺﾞｼｯｸM"/>
        <a:cs typeface=""/>
      </a:majorFont>
      <a:minorFont>
        <a:latin typeface="Times New Roman"/>
        <a:ea typeface="HG明朝E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994</TotalTime>
  <Words>306</Words>
  <Application>Microsoft Office PowerPoint</Application>
  <PresentationFormat>画面に合わせる (4:3)</PresentationFormat>
  <Paragraphs>11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​​テーマ</vt:lpstr>
      <vt:lpstr>PowerPoint プレゼンテーション</vt:lpstr>
    </vt:vector>
  </TitlesOfParts>
  <Company>Toshib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omo</dc:creator>
  <cp:lastModifiedBy>崇史 黒江</cp:lastModifiedBy>
  <cp:revision>590</cp:revision>
  <cp:lastPrinted>2021-05-31T23:33:41Z</cp:lastPrinted>
  <dcterms:created xsi:type="dcterms:W3CDTF">2016-07-10T13:11:22Z</dcterms:created>
  <dcterms:modified xsi:type="dcterms:W3CDTF">2022-03-01T07:37:01Z</dcterms:modified>
</cp:coreProperties>
</file>